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951663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F2874-F13A-4843-A74C-3B48CE833A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D2A88-72D3-4888-83ED-492FD2C5D2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15AB2D-EE98-49DA-8B8A-98F69D930B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B14294-553D-44A4-B2FB-A75E6535C8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0B1A0-795D-4B05-9597-A7510B2D3E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79FDD-B37A-4357-A571-5F29EE11B6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7EBD1-03DD-4E86-A374-5202E2B2FA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CDF63-9706-4534-BB30-984C60E770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4AA3A9-84C8-4F36-A564-494ED60D39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230EE9-260A-42FD-A40B-256A4FBB66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F43E2-8C8E-4BBA-A8A5-97D1FADB7C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B28A6-9644-4072-BF8A-E4EA13CA93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4BA4B8-5E62-49E6-B322-A9B942107DF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44560" y="2930400"/>
            <a:ext cx="74851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14. Gene Ontology analysis of transcripts whose variance are strongly dependent upon growth condition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DAGs represent the relationships of categories (shown in red) that are enriched for transcripts where growth conditions accounted for over 50% of the observed variance in gene expression (see Supplemental Table S8 for complete gene lists). Transcripts that are up-regulated (A) or down-regulated (B) in xenografts relative to cultured cells are provided. When space permitted, the names of genes in terminal categories of each DAG are provided the blu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/>
          <p:nvPr/>
        </p:nvSpPr>
        <p:spPr>
          <a:xfrm>
            <a:off x="70920" y="6510240"/>
            <a:ext cx="247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gda et al. Additional File 14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3917880" y="236520"/>
            <a:ext cx="2073240" cy="623268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3605760" y="5342040"/>
            <a:ext cx="741600" cy="146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3366ff"/>
                </a:solidFill>
                <a:latin typeface="Arial"/>
              </a:rPr>
              <a:t>HNRP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3366ff"/>
                </a:solidFill>
                <a:latin typeface="Arial"/>
              </a:rPr>
              <a:t>HNRPH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3366ff"/>
                </a:solidFill>
                <a:latin typeface="Arial"/>
              </a:rPr>
              <a:t>PRPF40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3366ff"/>
                </a:solidFill>
                <a:latin typeface="Arial"/>
              </a:rPr>
              <a:t>RBM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3366ff"/>
                </a:solidFill>
                <a:latin typeface="Arial"/>
              </a:rPr>
              <a:t>SFPQ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3366ff"/>
                </a:solidFill>
                <a:latin typeface="Arial"/>
              </a:rPr>
              <a:t>SFRS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3366ff"/>
                </a:solidFill>
                <a:latin typeface="Arial"/>
              </a:rPr>
              <a:t>SFRS2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3366ff"/>
                </a:solidFill>
                <a:latin typeface="Arial"/>
              </a:rPr>
              <a:t>SFRS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3366ff"/>
                </a:solidFill>
                <a:latin typeface="Arial"/>
              </a:rPr>
              <a:t>TRA2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H="1" flipV="1">
            <a:off x="4382640" y="5400360"/>
            <a:ext cx="544680" cy="314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4457880" y="6426360"/>
            <a:ext cx="482400" cy="27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76320" y="241200"/>
            <a:ext cx="9067680" cy="477864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1540440" y="4662360"/>
            <a:ext cx="541800" cy="94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ALDO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DL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ENO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MDH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DH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GA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GK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188880" y="4408560"/>
            <a:ext cx="569160" cy="70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A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GAR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GM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IMPDH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AIC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598280" y="4389480"/>
            <a:ext cx="627120" cy="70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sv-SE" sz="800" spc="-1" strike="noStrike">
                <a:solidFill>
                  <a:srgbClr val="3366ff"/>
                </a:solidFill>
                <a:latin typeface="Arial"/>
              </a:rPr>
              <a:t>GRPEL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sv-SE" sz="800" spc="-1" strike="noStrike">
                <a:solidFill>
                  <a:srgbClr val="3366ff"/>
                </a:solidFill>
                <a:latin typeface="Arial"/>
              </a:rPr>
              <a:t>TIMM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sv-SE" sz="800" spc="-1" strike="noStrike">
                <a:solidFill>
                  <a:srgbClr val="3366ff"/>
                </a:solidFill>
                <a:latin typeface="Arial"/>
              </a:rPr>
              <a:t>TIMM17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sv-SE" sz="800" spc="-1" strike="noStrike">
                <a:solidFill>
                  <a:srgbClr val="3366ff"/>
                </a:solidFill>
                <a:latin typeface="Arial"/>
              </a:rPr>
              <a:t>TIMM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sv-SE" sz="800" spc="-1" strike="noStrike">
                <a:solidFill>
                  <a:srgbClr val="3366ff"/>
                </a:solidFill>
                <a:latin typeface="Arial"/>
              </a:rPr>
              <a:t>TOMM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661000" y="3182760"/>
            <a:ext cx="590400" cy="70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NDUF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NDUFA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NDUFA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NDUFB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NDUFS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184520" y="4992840"/>
            <a:ext cx="675720" cy="130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CY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HCC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H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SDH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SLC25A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TIMM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TIMM17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TIMM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UQCR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UQCR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862040" y="4992840"/>
            <a:ext cx="592200" cy="94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MRPL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MRPL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MRPL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MRPL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MRPL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MRPS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MRPS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8344800" y="4992840"/>
            <a:ext cx="627120" cy="106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CY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SDH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TIMM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TIMM17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TIMM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TOMM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UQCR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UQCR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631720" y="3220920"/>
            <a:ext cx="531000" cy="82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SMB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SMB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SMB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SMB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SMB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SMB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91600" y="3176640"/>
            <a:ext cx="491400" cy="70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APR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GAR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GM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PAIC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-29880" y="1851120"/>
            <a:ext cx="497520" cy="73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3366ff"/>
                </a:solidFill>
                <a:latin typeface="Arial"/>
              </a:rPr>
              <a:t>DD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3366ff"/>
                </a:solidFill>
                <a:latin typeface="Arial"/>
              </a:rPr>
              <a:t>GAR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3366ff"/>
                </a:solidFill>
                <a:latin typeface="Arial"/>
              </a:rPr>
              <a:t>GMP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3366ff"/>
                </a:solidFill>
                <a:latin typeface="Arial"/>
              </a:rPr>
              <a:t>HMOX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3366ff"/>
                </a:solidFill>
                <a:latin typeface="Arial"/>
              </a:rPr>
              <a:t>PAIC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089000" y="3965400"/>
            <a:ext cx="590400" cy="70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F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MDH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SDH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SDH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66ff"/>
                </a:solidFill>
                <a:latin typeface="Arial"/>
              </a:rPr>
              <a:t>SUCLG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70920" y="6510240"/>
            <a:ext cx="247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gda et al. Additional File 14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22T01:39:07Z</dcterms:created>
  <dc:creator>Joseph G. Hacia</dc:creator>
  <dc:description/>
  <dc:language>en-US</dc:language>
  <cp:lastModifiedBy>Joseph G. Hacia</cp:lastModifiedBy>
  <dcterms:modified xsi:type="dcterms:W3CDTF">2008-07-17T06:37:35Z</dcterms:modified>
  <cp:revision>31</cp:revision>
  <dc:subject/>
  <dc:title>Slide 1</dc:title>
</cp:coreProperties>
</file>